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5992B2A0-26EF-4FA6-9944-1B2B1BE06D3C}"/>
    <pc:docChg chg="custSel delSld modSld">
      <pc:chgData name="Mireille Vankemmelbeke" userId="e2496c92-8ae2-4817-81db-1e2fdf7923b3" providerId="ADAL" clId="{5992B2A0-26EF-4FA6-9944-1B2B1BE06D3C}" dt="2024-06-21T15:43:17.125" v="50" actId="47"/>
      <pc:docMkLst>
        <pc:docMk/>
      </pc:docMkLst>
      <pc:sldChg chg="del">
        <pc:chgData name="Mireille Vankemmelbeke" userId="e2496c92-8ae2-4817-81db-1e2fdf7923b3" providerId="ADAL" clId="{5992B2A0-26EF-4FA6-9944-1B2B1BE06D3C}" dt="2024-06-21T15:42:54.043" v="0" actId="47"/>
        <pc:sldMkLst>
          <pc:docMk/>
          <pc:sldMk cId="3935331238" sldId="268"/>
        </pc:sldMkLst>
      </pc:sldChg>
      <pc:sldChg chg="delSp modSp mod">
        <pc:chgData name="Mireille Vankemmelbeke" userId="e2496c92-8ae2-4817-81db-1e2fdf7923b3" providerId="ADAL" clId="{5992B2A0-26EF-4FA6-9944-1B2B1BE06D3C}" dt="2024-06-21T15:43:14.908" v="49" actId="478"/>
        <pc:sldMkLst>
          <pc:docMk/>
          <pc:sldMk cId="868960993" sldId="269"/>
        </pc:sldMkLst>
        <pc:spChg chg="mod">
          <ac:chgData name="Mireille Vankemmelbeke" userId="e2496c92-8ae2-4817-81db-1e2fdf7923b3" providerId="ADAL" clId="{5992B2A0-26EF-4FA6-9944-1B2B1BE06D3C}" dt="2024-06-21T15:43:08.973" v="25" actId="1035"/>
          <ac:spMkLst>
            <pc:docMk/>
            <pc:sldMk cId="868960993" sldId="269"/>
            <ac:spMk id="4" creationId="{5E3CACEE-8BE5-F31F-E9D6-FEF2DBE2523D}"/>
          </ac:spMkLst>
        </pc:spChg>
        <pc:spChg chg="del">
          <ac:chgData name="Mireille Vankemmelbeke" userId="e2496c92-8ae2-4817-81db-1e2fdf7923b3" providerId="ADAL" clId="{5992B2A0-26EF-4FA6-9944-1B2B1BE06D3C}" dt="2024-06-21T15:43:14.908" v="49" actId="478"/>
          <ac:spMkLst>
            <pc:docMk/>
            <pc:sldMk cId="868960993" sldId="269"/>
            <ac:spMk id="7" creationId="{83275967-3BAD-8453-FBF6-8E47B83E5243}"/>
          </ac:spMkLst>
        </pc:spChg>
        <pc:spChg chg="del">
          <ac:chgData name="Mireille Vankemmelbeke" userId="e2496c92-8ae2-4817-81db-1e2fdf7923b3" providerId="ADAL" clId="{5992B2A0-26EF-4FA6-9944-1B2B1BE06D3C}" dt="2024-06-21T15:43:14.908" v="49" actId="478"/>
          <ac:spMkLst>
            <pc:docMk/>
            <pc:sldMk cId="868960993" sldId="269"/>
            <ac:spMk id="9" creationId="{A86364A3-3171-51B5-56DC-97814CC6E14F}"/>
          </ac:spMkLst>
        </pc:spChg>
        <pc:spChg chg="del">
          <ac:chgData name="Mireille Vankemmelbeke" userId="e2496c92-8ae2-4817-81db-1e2fdf7923b3" providerId="ADAL" clId="{5992B2A0-26EF-4FA6-9944-1B2B1BE06D3C}" dt="2024-06-21T15:43:14.908" v="49" actId="478"/>
          <ac:spMkLst>
            <pc:docMk/>
            <pc:sldMk cId="868960993" sldId="269"/>
            <ac:spMk id="10" creationId="{A6EE4B9E-931A-D0B8-45E9-DDDDD02F55DB}"/>
          </ac:spMkLst>
        </pc:spChg>
        <pc:spChg chg="mod">
          <ac:chgData name="Mireille Vankemmelbeke" userId="e2496c92-8ae2-4817-81db-1e2fdf7923b3" providerId="ADAL" clId="{5992B2A0-26EF-4FA6-9944-1B2B1BE06D3C}" dt="2024-06-21T15:43:02.579" v="1" actId="1076"/>
          <ac:spMkLst>
            <pc:docMk/>
            <pc:sldMk cId="868960993" sldId="269"/>
            <ac:spMk id="13" creationId="{6625F3AB-E145-5FC1-46A0-49170BFF6139}"/>
          </ac:spMkLst>
        </pc:spChg>
        <pc:spChg chg="del">
          <ac:chgData name="Mireille Vankemmelbeke" userId="e2496c92-8ae2-4817-81db-1e2fdf7923b3" providerId="ADAL" clId="{5992B2A0-26EF-4FA6-9944-1B2B1BE06D3C}" dt="2024-06-21T15:43:14.908" v="49" actId="478"/>
          <ac:spMkLst>
            <pc:docMk/>
            <pc:sldMk cId="868960993" sldId="269"/>
            <ac:spMk id="14" creationId="{C0AD6B4A-FDED-1CF3-8BBF-3C89DC9125F8}"/>
          </ac:spMkLst>
        </pc:spChg>
        <pc:spChg chg="del">
          <ac:chgData name="Mireille Vankemmelbeke" userId="e2496c92-8ae2-4817-81db-1e2fdf7923b3" providerId="ADAL" clId="{5992B2A0-26EF-4FA6-9944-1B2B1BE06D3C}" dt="2024-06-21T15:43:14.908" v="49" actId="478"/>
          <ac:spMkLst>
            <pc:docMk/>
            <pc:sldMk cId="868960993" sldId="269"/>
            <ac:spMk id="15" creationId="{AAA63D9A-720A-38FA-30FE-B64A03B0D307}"/>
          </ac:spMkLst>
        </pc:spChg>
        <pc:picChg chg="mod">
          <ac:chgData name="Mireille Vankemmelbeke" userId="e2496c92-8ae2-4817-81db-1e2fdf7923b3" providerId="ADAL" clId="{5992B2A0-26EF-4FA6-9944-1B2B1BE06D3C}" dt="2024-06-21T15:43:11.099" v="48" actId="1035"/>
          <ac:picMkLst>
            <pc:docMk/>
            <pc:sldMk cId="868960993" sldId="269"/>
            <ac:picMk id="3" creationId="{07C6B656-125D-EBDD-6A94-0B7A000C716B}"/>
          </ac:picMkLst>
        </pc:picChg>
        <pc:picChg chg="del">
          <ac:chgData name="Mireille Vankemmelbeke" userId="e2496c92-8ae2-4817-81db-1e2fdf7923b3" providerId="ADAL" clId="{5992B2A0-26EF-4FA6-9944-1B2B1BE06D3C}" dt="2024-06-21T15:43:14.908" v="49" actId="478"/>
          <ac:picMkLst>
            <pc:docMk/>
            <pc:sldMk cId="868960993" sldId="269"/>
            <ac:picMk id="11" creationId="{1B83C6A4-C081-437D-17C4-D1FA03343D30}"/>
          </ac:picMkLst>
        </pc:picChg>
        <pc:picChg chg="del">
          <ac:chgData name="Mireille Vankemmelbeke" userId="e2496c92-8ae2-4817-81db-1e2fdf7923b3" providerId="ADAL" clId="{5992B2A0-26EF-4FA6-9944-1B2B1BE06D3C}" dt="2024-06-21T15:43:14.908" v="49" actId="478"/>
          <ac:picMkLst>
            <pc:docMk/>
            <pc:sldMk cId="868960993" sldId="269"/>
            <ac:picMk id="16" creationId="{436ACC07-BBAC-908B-678D-4EE4BA15215E}"/>
          </ac:picMkLst>
        </pc:picChg>
        <pc:picChg chg="del">
          <ac:chgData name="Mireille Vankemmelbeke" userId="e2496c92-8ae2-4817-81db-1e2fdf7923b3" providerId="ADAL" clId="{5992B2A0-26EF-4FA6-9944-1B2B1BE06D3C}" dt="2024-06-21T15:43:14.908" v="49" actId="478"/>
          <ac:picMkLst>
            <pc:docMk/>
            <pc:sldMk cId="868960993" sldId="269"/>
            <ac:picMk id="17" creationId="{BD10C5BA-FE39-7C16-D7AC-4A4000C9580F}"/>
          </ac:picMkLst>
        </pc:picChg>
        <pc:picChg chg="del">
          <ac:chgData name="Mireille Vankemmelbeke" userId="e2496c92-8ae2-4817-81db-1e2fdf7923b3" providerId="ADAL" clId="{5992B2A0-26EF-4FA6-9944-1B2B1BE06D3C}" dt="2024-06-21T15:43:14.908" v="49" actId="478"/>
          <ac:picMkLst>
            <pc:docMk/>
            <pc:sldMk cId="868960993" sldId="269"/>
            <ac:picMk id="19" creationId="{56993332-3CBE-EF21-6E05-DD9C043541F3}"/>
          </ac:picMkLst>
        </pc:picChg>
      </pc:sldChg>
      <pc:sldChg chg="del">
        <pc:chgData name="Mireille Vankemmelbeke" userId="e2496c92-8ae2-4817-81db-1e2fdf7923b3" providerId="ADAL" clId="{5992B2A0-26EF-4FA6-9944-1B2B1BE06D3C}" dt="2024-06-21T15:43:17.125" v="50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5E3CACEE-8BE5-F31F-E9D6-FEF2DBE2523D}"/>
              </a:ext>
            </a:extLst>
          </p:cNvPr>
          <p:cNvSpPr txBox="1"/>
          <p:nvPr/>
        </p:nvSpPr>
        <p:spPr>
          <a:xfrm>
            <a:off x="100931" y="1092673"/>
            <a:ext cx="665613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/>
              <a:t>Supplemental Figure 5</a:t>
            </a:r>
            <a:r>
              <a:rPr lang="en-GB" sz="900"/>
              <a:t>. SC134-TCB induced </a:t>
            </a:r>
            <a:r>
              <a:rPr lang="en-GB" sz="900" err="1"/>
              <a:t>IFNy</a:t>
            </a:r>
            <a:r>
              <a:rPr lang="en-GB" sz="900"/>
              <a:t> by Pan T cells cocultured with DMS79 (5:1, e:T) or primary endothelial cell control (HUVEC) for 24 hours (</a:t>
            </a:r>
            <a:r>
              <a:rPr lang="en-GB" sz="900" err="1"/>
              <a:t>Elispot</a:t>
            </a:r>
            <a:r>
              <a:rPr lang="en-GB" sz="900"/>
              <a:t>). Mean and standard deviation shown for triplicate samples.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625F3AB-E145-5FC1-46A0-49170BFF6139}"/>
              </a:ext>
            </a:extLst>
          </p:cNvPr>
          <p:cNvSpPr txBox="1">
            <a:spLocks/>
          </p:cNvSpPr>
          <p:nvPr/>
        </p:nvSpPr>
        <p:spPr>
          <a:xfrm>
            <a:off x="0" y="6317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7C6B656-125D-EBDD-6A94-0B7A000C71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724" r="3272"/>
          <a:stretch/>
        </p:blipFill>
        <p:spPr>
          <a:xfrm>
            <a:off x="518795" y="1521734"/>
            <a:ext cx="2213326" cy="1633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96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43:22Z</dcterms:modified>
</cp:coreProperties>
</file>